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7C59A-CC98-414E-987A-0FF18795AC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1339BB-A9FD-4546-8956-746DE26E89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D1C56-9533-4F0D-A76D-27DF28FABE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A2E01C-A4AF-440D-9DB7-B99A81B020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CD17D-5D91-4F84-90AD-D225310E0F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47F73-0375-4B20-84B7-140BC7A8BB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CF980E-E58E-4751-8D47-E8FE880FE7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AF755-1E36-403A-B092-DBE9428810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1B9D06-4B32-4782-BAA7-4F46217DBE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77BA08-7AD1-4ECA-A41C-F5A4B6EABA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3BD79-5B77-485E-8164-AC8D6CDED9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41AAB-B071-4130-9A87-9B1954B0D9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24605A-4AC1-4C7B-8647-3702156C6B5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1" descr=""/>
          <p:cNvPicPr/>
          <p:nvPr/>
        </p:nvPicPr>
        <p:blipFill>
          <a:blip r:embed="rId1"/>
          <a:stretch/>
        </p:blipFill>
        <p:spPr>
          <a:xfrm>
            <a:off x="1047600" y="579600"/>
            <a:ext cx="7059600" cy="324324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3"/>
          <p:cNvSpPr/>
          <p:nvPr/>
        </p:nvSpPr>
        <p:spPr>
          <a:xfrm>
            <a:off x="1238400" y="4080960"/>
            <a:ext cx="665784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igure S3. Extent of similarity of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. virguliforme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 genes with that of the selected organisms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The blue line indicates the percentag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. virguliform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genes that are similar (E ≤ 9) to selected organisms. Brown line represents the proportion of genes in an individual that showed similarity (E ≤ 9) to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. virguliform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genes.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TextBox 1" descr=""/>
          <p:cNvPicPr/>
          <p:nvPr/>
        </p:nvPicPr>
        <p:blipFill>
          <a:blip r:embed="rId2"/>
          <a:stretch/>
        </p:blipFill>
        <p:spPr>
          <a:xfrm>
            <a:off x="858960" y="652320"/>
            <a:ext cx="457200" cy="2121120"/>
          </a:xfrm>
          <a:prstGeom prst="rect">
            <a:avLst/>
          </a:prstGeom>
          <a:ln w="0">
            <a:noFill/>
          </a:ln>
        </p:spPr>
      </p:pic>
      <p:sp>
        <p:nvSpPr>
          <p:cNvPr id="44" name="Straight Connector 5"/>
          <p:cNvSpPr/>
          <p:nvPr/>
        </p:nvSpPr>
        <p:spPr>
          <a:xfrm>
            <a:off x="1047600" y="1181160"/>
            <a:ext cx="0" cy="30492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Group 12"/>
          <p:cNvGrpSpPr/>
          <p:nvPr/>
        </p:nvGrpSpPr>
        <p:grpSpPr>
          <a:xfrm>
            <a:off x="8040600" y="577800"/>
            <a:ext cx="397080" cy="2139840"/>
            <a:chOff x="8040600" y="577800"/>
            <a:chExt cx="397080" cy="2139840"/>
          </a:xfrm>
        </p:grpSpPr>
        <p:pic>
          <p:nvPicPr>
            <p:cNvPr id="46" name="TextBox 1" descr=""/>
            <p:cNvPicPr/>
            <p:nvPr/>
          </p:nvPicPr>
          <p:blipFill>
            <a:blip r:embed="rId3"/>
            <a:stretch/>
          </p:blipFill>
          <p:spPr>
            <a:xfrm>
              <a:off x="8040600" y="577800"/>
              <a:ext cx="397080" cy="2139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Straight Connector 8"/>
            <p:cNvSpPr/>
            <p:nvPr/>
          </p:nvSpPr>
          <p:spPr>
            <a:xfrm>
              <a:off x="8229960" y="1103400"/>
              <a:ext cx="0" cy="295200"/>
            </a:xfrm>
            <a:prstGeom prst="line">
              <a:avLst/>
            </a:prstGeom>
            <a:ln w="38160">
              <a:solidFill>
                <a:srgbClr val="c0504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Bhattacharyya, Madan K [AGRON]</dc:creator>
  <dc:description/>
  <dc:language>en-US</dc:language>
  <cp:lastModifiedBy>Bhattacharyya, Madan K [AGRON]</cp:lastModifiedBy>
  <dcterms:modified xsi:type="dcterms:W3CDTF">2013-10-23T22:41:05Z</dcterms:modified>
  <cp:revision>485</cp:revision>
  <dc:subject/>
  <dc:title>Slide 1</dc:title>
</cp:coreProperties>
</file>